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0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40243B-C9D9-4E37-8A9B-975BA0714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A714692-240B-41C5-8C90-F164BAD8D7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9EF380-C5C3-4129-8EEE-D4E623AC8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BB1000-A6C0-4C62-B2EA-1FD1D9783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E3F364-DC77-44FD-8491-23302B6B0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61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F54C79-CE91-4E61-8E4D-D33854ED0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DFD16E-473E-4D8B-A930-A65036E80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A1B09-20F6-48E8-B7A4-59C60E4C6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D38E91-8B3C-42C4-81BA-2A528F65A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8CFB91-036B-455E-ADB7-9BCA99A45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755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AF64375-249E-4A22-B075-930765B156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0D4BDBB-E397-401F-81CC-ACD122A42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2B769-92F2-4A7C-A9AE-92647EE79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978F82-22F3-4700-905C-B8BF30FA6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A028F0-7A7E-4402-8B38-E013B57CE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94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32A81-633D-4770-80E3-A7A9DDD1B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7CBB39-00E4-41AC-A959-E946ABF61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656EC8-08E9-44FD-BCFA-0F41EB319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44FEB1-A99B-445C-9FDD-26525761A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1EB348-1246-4E52-9BF8-63186A603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57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2F3AAD-9A47-4021-9DD9-6228DA476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04A4F6-104B-419C-BB48-F4C993E0F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BA6A41-D01F-42A5-A0CB-C3858E782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B6E1E1-1D4E-46ED-ABE7-9809687FE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CF9A44-A457-4832-BF3D-DD4F4B160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45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DFBED2-9502-4A6E-9B63-6FD5D4C81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38064D-07F7-4F1C-B27F-2EBBE2CB19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ADBD82-67F9-480E-9432-3763B19B37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2A9A7C-C81A-4CA4-975E-A60478CCD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52C19B-593E-4BA2-BB98-C13F5328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69C6D4-056C-4CB7-A498-2298945DB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51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32F730-5371-47F1-B409-A5EA0A7D76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7530FC-E9BF-4073-8401-C6C23EF02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936AD0-1C01-439A-B5AA-D0CF7C96C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27F032-1417-4983-B5B7-DBC3D6FFD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1EC7F1C-5D7C-4352-B083-8B2D581E6D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578B67B-AF5E-4672-9A72-D4789F00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85725B8-1C48-419D-B7F3-8927ABCAA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82102D0-C63F-4A18-A7D1-BA31B9A89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6365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659908-829A-456D-96A3-24686DDA2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A86B67D-AF34-4215-A1F8-513DA4717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00DA581-5376-4789-9A85-EE2D12191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AB3051E-C5C3-47E4-A22A-EB298DC97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9717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2BEF6F9-93DC-4307-9D39-F0E43AF5A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D19725D-91E4-4FEE-8026-BE495B9B6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6FA0E68-5D0B-4062-AD51-69B71FEFA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552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426F6B-2031-490C-A5A1-65A46833B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5BFA83-4F0E-48B7-A0D0-99003B0259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35C5ED-0C58-4A9C-AFAC-BDAC71E895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E7E3A4-5DDB-4572-BEE1-ADA34AA13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C9AD49-1057-4906-AD26-A3BF50F48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353386-48BC-441A-AF4F-EA28190F8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293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4EF8F9-F59E-4069-8FE5-2FE2FE57F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A3F154-31B2-4BEE-94E9-6B8D74BAAF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1A9FAF-7263-4725-A1FD-9E39D8EFA0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23A9AF-2003-4B75-81D2-AA19AE85A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697D45-5293-4E16-AD0B-CFCBA799F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DA7F62-83E4-4285-8BB4-718119A4D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479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46B0D66-E7A9-404C-802C-1EBC6B2DE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3C41F8-CAC3-4F72-B536-F69A4C9D7F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2B3CA-E3A6-4CCE-9F05-A2E288C4AB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5B4F2E-532A-4F73-B9F5-358176767D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FCDDD7-43F4-42EC-A33C-A6605D4619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141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E</a:t>
            </a:r>
            <a:endParaRPr lang="zh-CN" altLang="en-US" dirty="0"/>
          </a:p>
        </p:txBody>
      </p:sp>
      <p:sp>
        <p:nvSpPr>
          <p:cNvPr id="7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SpPr txBox="1"/>
          <p:nvPr/>
        </p:nvSpPr>
        <p:spPr>
          <a:xfrm>
            <a:off x="2155829" y="2328671"/>
            <a:ext cx="137350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ontrol shRNA</a:t>
            </a:r>
          </a:p>
        </p:txBody>
      </p:sp>
      <p:sp>
        <p:nvSpPr>
          <p:cNvPr id="18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SpPr txBox="1"/>
          <p:nvPr/>
        </p:nvSpPr>
        <p:spPr>
          <a:xfrm>
            <a:off x="2127257" y="3814571"/>
            <a:ext cx="146875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sestrin2 shRNA</a:t>
            </a:r>
          </a:p>
        </p:txBody>
      </p:sp>
      <p:sp>
        <p:nvSpPr>
          <p:cNvPr id="19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SpPr txBox="1"/>
          <p:nvPr/>
        </p:nvSpPr>
        <p:spPr>
          <a:xfrm>
            <a:off x="5534691" y="4604374"/>
            <a:ext cx="4495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is</a:t>
            </a:r>
          </a:p>
        </p:txBody>
      </p:sp>
      <p:sp>
        <p:nvSpPr>
          <p:cNvPr id="20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SpPr txBox="1"/>
          <p:nvPr/>
        </p:nvSpPr>
        <p:spPr>
          <a:xfrm>
            <a:off x="6944391" y="4604365"/>
            <a:ext cx="5067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Dox</a:t>
            </a:r>
          </a:p>
        </p:txBody>
      </p:sp>
      <p:sp>
        <p:nvSpPr>
          <p:cNvPr id="22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SpPr txBox="1"/>
          <p:nvPr/>
        </p:nvSpPr>
        <p:spPr>
          <a:xfrm>
            <a:off x="8449341" y="4604365"/>
            <a:ext cx="4876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Mtx</a:t>
            </a:r>
          </a:p>
        </p:txBody>
      </p:sp>
      <p:sp>
        <p:nvSpPr>
          <p:cNvPr id="23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SpPr txBox="1"/>
          <p:nvPr/>
        </p:nvSpPr>
        <p:spPr>
          <a:xfrm>
            <a:off x="4214183" y="4604365"/>
            <a:ext cx="24955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24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SpPr txBox="1"/>
          <p:nvPr/>
        </p:nvSpPr>
        <p:spPr>
          <a:xfrm>
            <a:off x="6077750" y="1275045"/>
            <a:ext cx="7734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MG-63</a:t>
            </a:r>
          </a:p>
        </p:txBody>
      </p:sp>
      <p:pic>
        <p:nvPicPr>
          <p:cNvPr id="25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3787" y="1790379"/>
            <a:ext cx="1323473" cy="1335046"/>
          </a:xfrm>
          <a:custGeom>
            <a:avLst/>
            <a:gdLst>
              <a:gd name="connsiteX0" fmla="*/ 61 w 1323473"/>
              <a:gd name="connsiteY0" fmla="*/ -147 h 1335046"/>
              <a:gd name="connsiteX1" fmla="*/ 1323535 w 1323473"/>
              <a:gd name="connsiteY1" fmla="*/ -147 h 1335046"/>
              <a:gd name="connsiteX2" fmla="*/ 1323535 w 1323473"/>
              <a:gd name="connsiteY2" fmla="*/ 1334899 h 1335046"/>
              <a:gd name="connsiteX3" fmla="*/ 61 w 1323473"/>
              <a:gd name="connsiteY3" fmla="*/ 1334899 h 13350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23473" h="1335046">
                <a:moveTo>
                  <a:pt x="61" y="-147"/>
                </a:moveTo>
                <a:lnTo>
                  <a:pt x="1323535" y="-147"/>
                </a:lnTo>
                <a:lnTo>
                  <a:pt x="1323535" y="1334899"/>
                </a:lnTo>
                <a:lnTo>
                  <a:pt x="61" y="1334899"/>
                </a:lnTo>
                <a:close/>
              </a:path>
            </a:pathLst>
          </a:custGeom>
        </p:spPr>
      </p:pic>
      <p:pic>
        <p:nvPicPr>
          <p:cNvPr id="26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207" t="33533" r="38122" b="32040"/>
          <a:stretch/>
        </p:blipFill>
        <p:spPr>
          <a:xfrm>
            <a:off x="3638550" y="3267622"/>
            <a:ext cx="1318710" cy="1335046"/>
          </a:xfrm>
          <a:custGeom>
            <a:avLst/>
            <a:gdLst>
              <a:gd name="connsiteX0" fmla="*/ -2431 w 5816681"/>
              <a:gd name="connsiteY0" fmla="*/ -1577 h 3877787"/>
              <a:gd name="connsiteX1" fmla="*/ 5814251 w 5816681"/>
              <a:gd name="connsiteY1" fmla="*/ -1577 h 3877787"/>
              <a:gd name="connsiteX2" fmla="*/ 5814251 w 5816681"/>
              <a:gd name="connsiteY2" fmla="*/ 3876211 h 3877787"/>
              <a:gd name="connsiteX3" fmla="*/ -2431 w 5816681"/>
              <a:gd name="connsiteY3" fmla="*/ 3876211 h 38777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816681" h="3877787">
                <a:moveTo>
                  <a:pt x="-2431" y="-1577"/>
                </a:moveTo>
                <a:lnTo>
                  <a:pt x="5814251" y="-1577"/>
                </a:lnTo>
                <a:lnTo>
                  <a:pt x="5814251" y="3876211"/>
                </a:lnTo>
                <a:lnTo>
                  <a:pt x="-2431" y="3876211"/>
                </a:lnTo>
                <a:close/>
              </a:path>
            </a:pathLst>
          </a:custGeom>
        </p:spPr>
      </p:pic>
      <p:pic>
        <p:nvPicPr>
          <p:cNvPr id="27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1913" y="3248329"/>
            <a:ext cx="1321595" cy="1335431"/>
          </a:xfrm>
          <a:custGeom>
            <a:avLst/>
            <a:gdLst>
              <a:gd name="connsiteX0" fmla="*/ 189 w 1321595"/>
              <a:gd name="connsiteY0" fmla="*/ -20 h 1335431"/>
              <a:gd name="connsiteX1" fmla="*/ 1321785 w 1321595"/>
              <a:gd name="connsiteY1" fmla="*/ -20 h 1335431"/>
              <a:gd name="connsiteX2" fmla="*/ 1321785 w 1321595"/>
              <a:gd name="connsiteY2" fmla="*/ 1335411 h 1335431"/>
              <a:gd name="connsiteX3" fmla="*/ 189 w 1321595"/>
              <a:gd name="connsiteY3" fmla="*/ 1335411 h 13354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21595" h="1335431">
                <a:moveTo>
                  <a:pt x="189" y="-20"/>
                </a:moveTo>
                <a:lnTo>
                  <a:pt x="1321785" y="-20"/>
                </a:lnTo>
                <a:lnTo>
                  <a:pt x="1321785" y="1335411"/>
                </a:lnTo>
                <a:lnTo>
                  <a:pt x="189" y="1335411"/>
                </a:lnTo>
                <a:close/>
              </a:path>
            </a:pathLst>
          </a:custGeom>
        </p:spPr>
      </p:pic>
      <p:pic>
        <p:nvPicPr>
          <p:cNvPr id="28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82863" y="1790379"/>
            <a:ext cx="1321745" cy="1335266"/>
          </a:xfrm>
          <a:custGeom>
            <a:avLst/>
            <a:gdLst>
              <a:gd name="connsiteX0" fmla="*/ 203 w 1321745"/>
              <a:gd name="connsiteY0" fmla="*/ -158 h 1335266"/>
              <a:gd name="connsiteX1" fmla="*/ 1321948 w 1321745"/>
              <a:gd name="connsiteY1" fmla="*/ -158 h 1335266"/>
              <a:gd name="connsiteX2" fmla="*/ 1321948 w 1321745"/>
              <a:gd name="connsiteY2" fmla="*/ 1335109 h 1335266"/>
              <a:gd name="connsiteX3" fmla="*/ 203 w 1321745"/>
              <a:gd name="connsiteY3" fmla="*/ 1335109 h 13352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21745" h="1335266">
                <a:moveTo>
                  <a:pt x="203" y="-158"/>
                </a:moveTo>
                <a:lnTo>
                  <a:pt x="1321948" y="-158"/>
                </a:lnTo>
                <a:lnTo>
                  <a:pt x="1321948" y="1335109"/>
                </a:lnTo>
                <a:lnTo>
                  <a:pt x="203" y="1335109"/>
                </a:lnTo>
                <a:close/>
              </a:path>
            </a:pathLst>
          </a:custGeom>
        </p:spPr>
      </p:pic>
      <p:pic>
        <p:nvPicPr>
          <p:cNvPr id="29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13756" y="1790379"/>
            <a:ext cx="1319670" cy="1335646"/>
          </a:xfrm>
          <a:custGeom>
            <a:avLst/>
            <a:gdLst>
              <a:gd name="connsiteX0" fmla="*/ 401 w 1319670"/>
              <a:gd name="connsiteY0" fmla="*/ -121 h 1335646"/>
              <a:gd name="connsiteX1" fmla="*/ 1320071 w 1319670"/>
              <a:gd name="connsiteY1" fmla="*/ -121 h 1335646"/>
              <a:gd name="connsiteX2" fmla="*/ 1320071 w 1319670"/>
              <a:gd name="connsiteY2" fmla="*/ 1335526 h 1335646"/>
              <a:gd name="connsiteX3" fmla="*/ 401 w 1319670"/>
              <a:gd name="connsiteY3" fmla="*/ 1335526 h 13356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19670" h="1335646">
                <a:moveTo>
                  <a:pt x="401" y="-121"/>
                </a:moveTo>
                <a:lnTo>
                  <a:pt x="1320071" y="-121"/>
                </a:lnTo>
                <a:lnTo>
                  <a:pt x="1320071" y="1335526"/>
                </a:lnTo>
                <a:lnTo>
                  <a:pt x="401" y="1335526"/>
                </a:lnTo>
                <a:close/>
              </a:path>
            </a:pathLst>
          </a:custGeom>
        </p:spPr>
      </p:pic>
      <p:pic>
        <p:nvPicPr>
          <p:cNvPr id="30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16528" y="3267379"/>
            <a:ext cx="1320185" cy="1336456"/>
          </a:xfrm>
          <a:custGeom>
            <a:avLst/>
            <a:gdLst>
              <a:gd name="connsiteX0" fmla="*/ 355 w 1320185"/>
              <a:gd name="connsiteY0" fmla="*/ -18 h 1336456"/>
              <a:gd name="connsiteX1" fmla="*/ 1320541 w 1320185"/>
              <a:gd name="connsiteY1" fmla="*/ -18 h 1336456"/>
              <a:gd name="connsiteX2" fmla="*/ 1320541 w 1320185"/>
              <a:gd name="connsiteY2" fmla="*/ 1336438 h 1336456"/>
              <a:gd name="connsiteX3" fmla="*/ 355 w 1320185"/>
              <a:gd name="connsiteY3" fmla="*/ 1336438 h 13364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20185" h="1336456">
                <a:moveTo>
                  <a:pt x="355" y="-18"/>
                </a:moveTo>
                <a:lnTo>
                  <a:pt x="1320541" y="-18"/>
                </a:lnTo>
                <a:lnTo>
                  <a:pt x="1320541" y="1336438"/>
                </a:lnTo>
                <a:lnTo>
                  <a:pt x="355" y="1336438"/>
                </a:lnTo>
                <a:close/>
              </a:path>
            </a:pathLst>
          </a:custGeom>
        </p:spPr>
      </p:pic>
      <p:pic>
        <p:nvPicPr>
          <p:cNvPr id="31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61614" y="3263816"/>
            <a:ext cx="1320664" cy="1337481"/>
          </a:xfrm>
          <a:custGeom>
            <a:avLst/>
            <a:gdLst>
              <a:gd name="connsiteX0" fmla="*/ 507 w 1320664"/>
              <a:gd name="connsiteY0" fmla="*/ -19 h 1337481"/>
              <a:gd name="connsiteX1" fmla="*/ 1321171 w 1320664"/>
              <a:gd name="connsiteY1" fmla="*/ -19 h 1337481"/>
              <a:gd name="connsiteX2" fmla="*/ 1321171 w 1320664"/>
              <a:gd name="connsiteY2" fmla="*/ 1337463 h 1337481"/>
              <a:gd name="connsiteX3" fmla="*/ 507 w 1320664"/>
              <a:gd name="connsiteY3" fmla="*/ 1337463 h 13374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20664" h="1337481">
                <a:moveTo>
                  <a:pt x="507" y="-19"/>
                </a:moveTo>
                <a:lnTo>
                  <a:pt x="1321171" y="-19"/>
                </a:lnTo>
                <a:lnTo>
                  <a:pt x="1321171" y="1337463"/>
                </a:lnTo>
                <a:lnTo>
                  <a:pt x="507" y="1337463"/>
                </a:lnTo>
                <a:close/>
              </a:path>
            </a:pathLst>
          </a:custGeom>
        </p:spPr>
      </p:pic>
      <p:pic>
        <p:nvPicPr>
          <p:cNvPr id="32" name="图形 5">
            <a:extLst>
              <a:ext uri="{FF2B5EF4-FFF2-40B4-BE49-F238E27FC236}">
                <a16:creationId xmlns:a16="http://schemas.microsoft.com/office/drawing/2014/main" id="{B639D071-7DD1-487A-AC62-36F38ACA2E3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961614" y="1790379"/>
            <a:ext cx="1322209" cy="1316736"/>
          </a:xfrm>
          <a:custGeom>
            <a:avLst/>
            <a:gdLst>
              <a:gd name="connsiteX0" fmla="*/ 554 w 1322209"/>
              <a:gd name="connsiteY0" fmla="*/ -121 h 1316736"/>
              <a:gd name="connsiteX1" fmla="*/ 1322763 w 1322209"/>
              <a:gd name="connsiteY1" fmla="*/ -121 h 1316736"/>
              <a:gd name="connsiteX2" fmla="*/ 1322763 w 1322209"/>
              <a:gd name="connsiteY2" fmla="*/ 1316615 h 1316736"/>
              <a:gd name="connsiteX3" fmla="*/ 554 w 1322209"/>
              <a:gd name="connsiteY3" fmla="*/ 1316615 h 13167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22209" h="1316736">
                <a:moveTo>
                  <a:pt x="554" y="-121"/>
                </a:moveTo>
                <a:lnTo>
                  <a:pt x="1322763" y="-121"/>
                </a:lnTo>
                <a:lnTo>
                  <a:pt x="1322763" y="1316615"/>
                </a:lnTo>
                <a:lnTo>
                  <a:pt x="554" y="1316615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2158387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J</a:t>
            </a:r>
            <a:endParaRPr lang="zh-CN" altLang="en-US" dirty="0"/>
          </a:p>
        </p:txBody>
      </p:sp>
      <p:grpSp>
        <p:nvGrpSpPr>
          <p:cNvPr id="5" name="图形 2">
            <a:extLst>
              <a:ext uri="{FF2B5EF4-FFF2-40B4-BE49-F238E27FC236}">
                <a16:creationId xmlns:a16="http://schemas.microsoft.com/office/drawing/2014/main" id="{22C4A1EA-D88F-4C96-979B-782823524438}"/>
              </a:ext>
            </a:extLst>
          </p:cNvPr>
          <p:cNvGrpSpPr/>
          <p:nvPr/>
        </p:nvGrpSpPr>
        <p:grpSpPr>
          <a:xfrm>
            <a:off x="2562225" y="2014861"/>
            <a:ext cx="5727904" cy="2803488"/>
            <a:chOff x="2562225" y="2014861"/>
            <a:chExt cx="5727904" cy="2803488"/>
          </a:xfrm>
        </p:grpSpPr>
        <p:pic>
          <p:nvPicPr>
            <p:cNvPr id="6" name="图形 2">
              <a:extLst>
                <a:ext uri="{FF2B5EF4-FFF2-40B4-BE49-F238E27FC236}">
                  <a16:creationId xmlns:a16="http://schemas.microsoft.com/office/drawing/2014/main" id="{44AEA35C-E883-4668-B12E-2F362D053B0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73094" y="2014861"/>
              <a:ext cx="1359049" cy="1322809"/>
            </a:xfrm>
            <a:custGeom>
              <a:avLst/>
              <a:gdLst>
                <a:gd name="connsiteX0" fmla="*/ -180 w 1359049"/>
                <a:gd name="connsiteY0" fmla="*/ -172 h 1322809"/>
                <a:gd name="connsiteX1" fmla="*/ 1358870 w 1359049"/>
                <a:gd name="connsiteY1" fmla="*/ -172 h 1322809"/>
                <a:gd name="connsiteX2" fmla="*/ 1358870 w 1359049"/>
                <a:gd name="connsiteY2" fmla="*/ 1322637 h 1322809"/>
                <a:gd name="connsiteX3" fmla="*/ -180 w 1359049"/>
                <a:gd name="connsiteY3" fmla="*/ 1322637 h 132280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59049" h="1322809">
                  <a:moveTo>
                    <a:pt x="-180" y="-172"/>
                  </a:moveTo>
                  <a:lnTo>
                    <a:pt x="1358870" y="-172"/>
                  </a:lnTo>
                  <a:lnTo>
                    <a:pt x="1358870" y="1322637"/>
                  </a:lnTo>
                  <a:lnTo>
                    <a:pt x="-180" y="1322637"/>
                  </a:lnTo>
                  <a:close/>
                </a:path>
              </a:pathLst>
            </a:custGeom>
          </p:spPr>
        </p:pic>
        <p:grpSp>
          <p:nvGrpSpPr>
            <p:cNvPr id="7" name="图形 2">
              <a:extLst>
                <a:ext uri="{FF2B5EF4-FFF2-40B4-BE49-F238E27FC236}">
                  <a16:creationId xmlns:a16="http://schemas.microsoft.com/office/drawing/2014/main" id="{C6979D85-4B8B-4F9C-8C71-DBE522AFFCE7}"/>
                </a:ext>
              </a:extLst>
            </p:cNvPr>
            <p:cNvGrpSpPr/>
            <p:nvPr/>
          </p:nvGrpSpPr>
          <p:grpSpPr>
            <a:xfrm>
              <a:off x="2562225" y="2014861"/>
              <a:ext cx="5727904" cy="2803488"/>
              <a:chOff x="2562225" y="2014861"/>
              <a:chExt cx="5727904" cy="2803488"/>
            </a:xfrm>
          </p:grpSpPr>
          <p:pic>
            <p:nvPicPr>
              <p:cNvPr id="8" name="图形 2">
                <a:extLst>
                  <a:ext uri="{FF2B5EF4-FFF2-40B4-BE49-F238E27FC236}">
                    <a16:creationId xmlns:a16="http://schemas.microsoft.com/office/drawing/2014/main" id="{DAADE651-238C-499A-9AC6-3CE702B340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468521" y="2017653"/>
                <a:ext cx="1359598" cy="1323914"/>
              </a:xfrm>
              <a:custGeom>
                <a:avLst/>
                <a:gdLst>
                  <a:gd name="connsiteX0" fmla="*/ 116 w 1359598"/>
                  <a:gd name="connsiteY0" fmla="*/ -180 h 1323914"/>
                  <a:gd name="connsiteX1" fmla="*/ 1359715 w 1359598"/>
                  <a:gd name="connsiteY1" fmla="*/ -180 h 1323914"/>
                  <a:gd name="connsiteX2" fmla="*/ 1359715 w 1359598"/>
                  <a:gd name="connsiteY2" fmla="*/ 1323734 h 1323914"/>
                  <a:gd name="connsiteX3" fmla="*/ 116 w 1359598"/>
                  <a:gd name="connsiteY3" fmla="*/ 1323734 h 13239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359598" h="1323914">
                    <a:moveTo>
                      <a:pt x="116" y="-180"/>
                    </a:moveTo>
                    <a:lnTo>
                      <a:pt x="1359715" y="-180"/>
                    </a:lnTo>
                    <a:lnTo>
                      <a:pt x="1359715" y="1323734"/>
                    </a:lnTo>
                    <a:lnTo>
                      <a:pt x="116" y="1323734"/>
                    </a:lnTo>
                    <a:close/>
                  </a:path>
                </a:pathLst>
              </a:custGeom>
            </p:spPr>
          </p:pic>
          <p:grpSp>
            <p:nvGrpSpPr>
              <p:cNvPr id="9" name="图形 2">
                <a:extLst>
                  <a:ext uri="{FF2B5EF4-FFF2-40B4-BE49-F238E27FC236}">
                    <a16:creationId xmlns:a16="http://schemas.microsoft.com/office/drawing/2014/main" id="{5E08418F-72C6-46A1-BFCA-BFF8AE8AC371}"/>
                  </a:ext>
                </a:extLst>
              </p:cNvPr>
              <p:cNvGrpSpPr/>
              <p:nvPr/>
            </p:nvGrpSpPr>
            <p:grpSpPr>
              <a:xfrm>
                <a:off x="2562225" y="2014861"/>
                <a:ext cx="5727904" cy="2803488"/>
                <a:chOff x="2562225" y="2014861"/>
                <a:chExt cx="5727904" cy="2803488"/>
              </a:xfrm>
            </p:grpSpPr>
            <p:pic>
              <p:nvPicPr>
                <p:cNvPr id="10" name="图形 2">
                  <a:extLst>
                    <a:ext uri="{FF2B5EF4-FFF2-40B4-BE49-F238E27FC236}">
                      <a16:creationId xmlns:a16="http://schemas.microsoft.com/office/drawing/2014/main" id="{5331C8DC-868E-4FB7-BE70-678912FE52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036428" y="2014861"/>
                  <a:ext cx="1360670" cy="1323914"/>
                </a:xfrm>
                <a:custGeom>
                  <a:avLst/>
                  <a:gdLst>
                    <a:gd name="connsiteX0" fmla="*/ -36 w 1360670"/>
                    <a:gd name="connsiteY0" fmla="*/ -180 h 1323914"/>
                    <a:gd name="connsiteX1" fmla="*/ 1360634 w 1360670"/>
                    <a:gd name="connsiteY1" fmla="*/ -180 h 1323914"/>
                    <a:gd name="connsiteX2" fmla="*/ 1360634 w 1360670"/>
                    <a:gd name="connsiteY2" fmla="*/ 1323734 h 1323914"/>
                    <a:gd name="connsiteX3" fmla="*/ -36 w 1360670"/>
                    <a:gd name="connsiteY3" fmla="*/ 1323734 h 132391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360670" h="1323914">
                      <a:moveTo>
                        <a:pt x="-36" y="-180"/>
                      </a:moveTo>
                      <a:lnTo>
                        <a:pt x="1360634" y="-180"/>
                      </a:lnTo>
                      <a:lnTo>
                        <a:pt x="1360634" y="1323734"/>
                      </a:lnTo>
                      <a:lnTo>
                        <a:pt x="-36" y="1323734"/>
                      </a:lnTo>
                      <a:close/>
                    </a:path>
                  </a:pathLst>
                </a:custGeom>
              </p:spPr>
            </p:pic>
            <p:grpSp>
              <p:nvGrpSpPr>
                <p:cNvPr id="11" name="图形 2">
                  <a:extLst>
                    <a:ext uri="{FF2B5EF4-FFF2-40B4-BE49-F238E27FC236}">
                      <a16:creationId xmlns:a16="http://schemas.microsoft.com/office/drawing/2014/main" id="{3741E7CD-7BBD-4AE8-AE93-DCA622642877}"/>
                    </a:ext>
                  </a:extLst>
                </p:cNvPr>
                <p:cNvGrpSpPr/>
                <p:nvPr/>
              </p:nvGrpSpPr>
              <p:grpSpPr>
                <a:xfrm>
                  <a:off x="2562225" y="2017655"/>
                  <a:ext cx="5727904" cy="2800693"/>
                  <a:chOff x="2562225" y="2017655"/>
                  <a:chExt cx="5727904" cy="2800693"/>
                </a:xfrm>
              </p:grpSpPr>
              <p:pic>
                <p:nvPicPr>
                  <p:cNvPr id="12" name="图形 2">
                    <a:extLst>
                      <a:ext uri="{FF2B5EF4-FFF2-40B4-BE49-F238E27FC236}">
                        <a16:creationId xmlns:a16="http://schemas.microsoft.com/office/drawing/2014/main" id="{16AA3CA1-3508-4F04-BACF-D8247BC5E7B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929142" y="2017655"/>
                    <a:ext cx="1360987" cy="1324708"/>
                  </a:xfrm>
                  <a:custGeom>
                    <a:avLst/>
                    <a:gdLst>
                      <a:gd name="connsiteX0" fmla="*/ 285 w 1360987"/>
                      <a:gd name="connsiteY0" fmla="*/ -156 h 1324708"/>
                      <a:gd name="connsiteX1" fmla="*/ 1361273 w 1360987"/>
                      <a:gd name="connsiteY1" fmla="*/ -156 h 1324708"/>
                      <a:gd name="connsiteX2" fmla="*/ 1361273 w 1360987"/>
                      <a:gd name="connsiteY2" fmla="*/ 1324552 h 1324708"/>
                      <a:gd name="connsiteX3" fmla="*/ 285 w 1360987"/>
                      <a:gd name="connsiteY3" fmla="*/ 1324552 h 132470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360987" h="1324708">
                        <a:moveTo>
                          <a:pt x="285" y="-156"/>
                        </a:moveTo>
                        <a:lnTo>
                          <a:pt x="1361273" y="-156"/>
                        </a:lnTo>
                        <a:lnTo>
                          <a:pt x="1361273" y="1324552"/>
                        </a:lnTo>
                        <a:lnTo>
                          <a:pt x="285" y="1324552"/>
                        </a:lnTo>
                        <a:close/>
                      </a:path>
                    </a:pathLst>
                  </a:custGeom>
                </p:spPr>
              </p:pic>
              <p:grpSp>
                <p:nvGrpSpPr>
                  <p:cNvPr id="13" name="图形 2">
                    <a:extLst>
                      <a:ext uri="{FF2B5EF4-FFF2-40B4-BE49-F238E27FC236}">
                        <a16:creationId xmlns:a16="http://schemas.microsoft.com/office/drawing/2014/main" id="{56AD48B4-12FC-4394-B25D-B8856D1BBD8E}"/>
                      </a:ext>
                    </a:extLst>
                  </p:cNvPr>
                  <p:cNvGrpSpPr/>
                  <p:nvPr/>
                </p:nvGrpSpPr>
                <p:grpSpPr>
                  <a:xfrm>
                    <a:off x="2562225" y="3492198"/>
                    <a:ext cx="5727904" cy="1326151"/>
                    <a:chOff x="2562225" y="3492198"/>
                    <a:chExt cx="5727904" cy="1326151"/>
                  </a:xfrm>
                </p:grpSpPr>
                <p:pic>
                  <p:nvPicPr>
                    <p:cNvPr id="14" name="图形 2">
                      <a:extLst>
                        <a:ext uri="{FF2B5EF4-FFF2-40B4-BE49-F238E27FC236}">
                          <a16:creationId xmlns:a16="http://schemas.microsoft.com/office/drawing/2014/main" id="{5A384662-2466-4647-A9F6-8A91990E75B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4037790" y="3492198"/>
                      <a:ext cx="1360987" cy="1326151"/>
                    </a:xfrm>
                    <a:custGeom>
                      <a:avLst/>
                      <a:gdLst>
                        <a:gd name="connsiteX0" fmla="*/ -18 w 1360987"/>
                        <a:gd name="connsiteY0" fmla="*/ -1 h 1326151"/>
                        <a:gd name="connsiteX1" fmla="*/ 1360969 w 1360987"/>
                        <a:gd name="connsiteY1" fmla="*/ -1 h 1326151"/>
                        <a:gd name="connsiteX2" fmla="*/ 1360969 w 1360987"/>
                        <a:gd name="connsiteY2" fmla="*/ 1326150 h 1326151"/>
                        <a:gd name="connsiteX3" fmla="*/ -18 w 1360987"/>
                        <a:gd name="connsiteY3" fmla="*/ 1326150 h 1326151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</a:cxnLst>
                      <a:rect l="l" t="t" r="r" b="b"/>
                      <a:pathLst>
                        <a:path w="1360987" h="1326151">
                          <a:moveTo>
                            <a:pt x="-18" y="-1"/>
                          </a:moveTo>
                          <a:lnTo>
                            <a:pt x="1360969" y="-1"/>
                          </a:lnTo>
                          <a:lnTo>
                            <a:pt x="1360969" y="1326150"/>
                          </a:lnTo>
                          <a:lnTo>
                            <a:pt x="-18" y="1326150"/>
                          </a:lnTo>
                          <a:close/>
                        </a:path>
                      </a:pathLst>
                    </a:custGeom>
                  </p:spPr>
                </p:pic>
                <p:grpSp>
                  <p:nvGrpSpPr>
                    <p:cNvPr id="15" name="图形 2">
                      <a:extLst>
                        <a:ext uri="{FF2B5EF4-FFF2-40B4-BE49-F238E27FC236}">
                          <a16:creationId xmlns:a16="http://schemas.microsoft.com/office/drawing/2014/main" id="{502C4EE9-F317-44A7-B0E6-DD1E4CE0643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62225" y="3492198"/>
                      <a:ext cx="5727904" cy="1325627"/>
                      <a:chOff x="2562225" y="3492198"/>
                      <a:chExt cx="5727904" cy="1325627"/>
                    </a:xfrm>
                  </p:grpSpPr>
                  <p:pic>
                    <p:nvPicPr>
                      <p:cNvPr id="16" name="图形 2">
                        <a:extLst>
                          <a:ext uri="{FF2B5EF4-FFF2-40B4-BE49-F238E27FC236}">
                            <a16:creationId xmlns:a16="http://schemas.microsoft.com/office/drawing/2014/main" id="{C316C0D9-7549-49D4-82AF-90A223A1EEAE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62225" y="3492198"/>
                        <a:ext cx="1360490" cy="1323936"/>
                      </a:xfrm>
                      <a:custGeom>
                        <a:avLst/>
                        <a:gdLst>
                          <a:gd name="connsiteX0" fmla="*/ -181 w 1360490"/>
                          <a:gd name="connsiteY0" fmla="*/ -9 h 1323936"/>
                          <a:gd name="connsiteX1" fmla="*/ 1360310 w 1360490"/>
                          <a:gd name="connsiteY1" fmla="*/ -9 h 1323936"/>
                          <a:gd name="connsiteX2" fmla="*/ 1360310 w 1360490"/>
                          <a:gd name="connsiteY2" fmla="*/ 1323928 h 1323936"/>
                          <a:gd name="connsiteX3" fmla="*/ -181 w 1360490"/>
                          <a:gd name="connsiteY3" fmla="*/ 1323928 h 1323936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</a:cxnLst>
                        <a:rect l="l" t="t" r="r" b="b"/>
                        <a:pathLst>
                          <a:path w="1360490" h="1323936">
                            <a:moveTo>
                              <a:pt x="-181" y="-9"/>
                            </a:moveTo>
                            <a:lnTo>
                              <a:pt x="1360310" y="-9"/>
                            </a:lnTo>
                            <a:lnTo>
                              <a:pt x="1360310" y="1323928"/>
                            </a:lnTo>
                            <a:lnTo>
                              <a:pt x="-181" y="1323928"/>
                            </a:lnTo>
                            <a:close/>
                          </a:path>
                        </a:pathLst>
                      </a:custGeom>
                    </p:spPr>
                  </p:pic>
                  <p:grpSp>
                    <p:nvGrpSpPr>
                      <p:cNvPr id="17" name="图形 2">
                        <a:extLst>
                          <a:ext uri="{FF2B5EF4-FFF2-40B4-BE49-F238E27FC236}">
                            <a16:creationId xmlns:a16="http://schemas.microsoft.com/office/drawing/2014/main" id="{C7B09BDF-7227-4D4F-8D83-CB358236360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468521" y="3493589"/>
                        <a:ext cx="2821607" cy="1324236"/>
                        <a:chOff x="5468521" y="3493589"/>
                        <a:chExt cx="2821607" cy="1324236"/>
                      </a:xfrm>
                    </p:grpSpPr>
                    <p:pic>
                      <p:nvPicPr>
                        <p:cNvPr id="18" name="图形 2">
                          <a:extLst>
                            <a:ext uri="{FF2B5EF4-FFF2-40B4-BE49-F238E27FC236}">
                              <a16:creationId xmlns:a16="http://schemas.microsoft.com/office/drawing/2014/main" id="{44F49F16-4C15-4921-BF20-B5F7D573B2F9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929142" y="3493598"/>
                          <a:ext cx="1360987" cy="1324227"/>
                        </a:xfrm>
                        <a:custGeom>
                          <a:avLst/>
                          <a:gdLst>
                            <a:gd name="connsiteX0" fmla="*/ 285 w 1360987"/>
                            <a:gd name="connsiteY0" fmla="*/ -1 h 1324227"/>
                            <a:gd name="connsiteX1" fmla="*/ 1361273 w 1360987"/>
                            <a:gd name="connsiteY1" fmla="*/ -1 h 1324227"/>
                            <a:gd name="connsiteX2" fmla="*/ 1361273 w 1360987"/>
                            <a:gd name="connsiteY2" fmla="*/ 1324226 h 1324227"/>
                            <a:gd name="connsiteX3" fmla="*/ 285 w 1360987"/>
                            <a:gd name="connsiteY3" fmla="*/ 1324226 h 1324227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</a:cxnLst>
                          <a:rect l="l" t="t" r="r" b="b"/>
                          <a:pathLst>
                            <a:path w="1360987" h="1324227">
                              <a:moveTo>
                                <a:pt x="285" y="-1"/>
                              </a:moveTo>
                              <a:lnTo>
                                <a:pt x="1361273" y="-1"/>
                              </a:lnTo>
                              <a:lnTo>
                                <a:pt x="1361273" y="1324226"/>
                              </a:lnTo>
                              <a:lnTo>
                                <a:pt x="285" y="1324226"/>
                              </a:lnTo>
                              <a:close/>
                            </a:path>
                          </a:pathLst>
                        </a:custGeom>
                      </p:spPr>
                    </p:pic>
                    <p:pic>
                      <p:nvPicPr>
                        <p:cNvPr id="19" name="图形 2">
                          <a:extLst>
                            <a:ext uri="{FF2B5EF4-FFF2-40B4-BE49-F238E27FC236}">
                              <a16:creationId xmlns:a16="http://schemas.microsoft.com/office/drawing/2014/main" id="{C5D49AC7-7045-4B30-8599-A4B730E7A7C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5468521" y="3493589"/>
                          <a:ext cx="1358569" cy="1322451"/>
                        </a:xfrm>
                        <a:custGeom>
                          <a:avLst/>
                          <a:gdLst>
                            <a:gd name="connsiteX0" fmla="*/ 124 w 1358569"/>
                            <a:gd name="connsiteY0" fmla="*/ -9 h 1322451"/>
                            <a:gd name="connsiteX1" fmla="*/ 1358694 w 1358569"/>
                            <a:gd name="connsiteY1" fmla="*/ -9 h 1322451"/>
                            <a:gd name="connsiteX2" fmla="*/ 1358694 w 1358569"/>
                            <a:gd name="connsiteY2" fmla="*/ 1322442 h 1322451"/>
                            <a:gd name="connsiteX3" fmla="*/ 124 w 1358569"/>
                            <a:gd name="connsiteY3" fmla="*/ 1322442 h 1322451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</a:cxnLst>
                          <a:rect l="l" t="t" r="r" b="b"/>
                          <a:pathLst>
                            <a:path w="1358569" h="1322451">
                              <a:moveTo>
                                <a:pt x="124" y="-9"/>
                              </a:moveTo>
                              <a:lnTo>
                                <a:pt x="1358694" y="-9"/>
                              </a:lnTo>
                              <a:lnTo>
                                <a:pt x="1358694" y="1322442"/>
                              </a:lnTo>
                              <a:lnTo>
                                <a:pt x="124" y="1322442"/>
                              </a:lnTo>
                              <a:close/>
                            </a:path>
                          </a:pathLst>
                        </a:custGeom>
                      </p:spPr>
                    </p:pic>
                  </p:grpSp>
                </p:grpSp>
              </p:grpSp>
            </p:grpSp>
          </p:grpSp>
        </p:grpSp>
      </p:grpSp>
      <p:sp>
        <p:nvSpPr>
          <p:cNvPr id="20" name="图形 2">
            <a:extLst>
              <a:ext uri="{FF2B5EF4-FFF2-40B4-BE49-F238E27FC236}">
                <a16:creationId xmlns:a16="http://schemas.microsoft.com/office/drawing/2014/main" id="{42AFCE5A-7506-4922-8031-169A0C18385F}"/>
              </a:ext>
            </a:extLst>
          </p:cNvPr>
          <p:cNvSpPr txBox="1"/>
          <p:nvPr/>
        </p:nvSpPr>
        <p:spPr>
          <a:xfrm>
            <a:off x="4482865" y="4818687"/>
            <a:ext cx="4495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is</a:t>
            </a:r>
          </a:p>
        </p:txBody>
      </p:sp>
      <p:sp>
        <p:nvSpPr>
          <p:cNvPr id="21" name="图形 2">
            <a:extLst>
              <a:ext uri="{FF2B5EF4-FFF2-40B4-BE49-F238E27FC236}">
                <a16:creationId xmlns:a16="http://schemas.microsoft.com/office/drawing/2014/main" id="{1042D93C-CA41-4CCF-B1B1-5CA935411408}"/>
              </a:ext>
            </a:extLst>
          </p:cNvPr>
          <p:cNvSpPr txBox="1"/>
          <p:nvPr/>
        </p:nvSpPr>
        <p:spPr>
          <a:xfrm>
            <a:off x="5930665" y="4818687"/>
            <a:ext cx="5067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Dox</a:t>
            </a:r>
          </a:p>
        </p:txBody>
      </p:sp>
      <p:sp>
        <p:nvSpPr>
          <p:cNvPr id="22" name="图形 2">
            <a:extLst>
              <a:ext uri="{FF2B5EF4-FFF2-40B4-BE49-F238E27FC236}">
                <a16:creationId xmlns:a16="http://schemas.microsoft.com/office/drawing/2014/main" id="{72586CBC-6608-47E9-8674-E996D34086D3}"/>
              </a:ext>
            </a:extLst>
          </p:cNvPr>
          <p:cNvSpPr txBox="1"/>
          <p:nvPr/>
        </p:nvSpPr>
        <p:spPr>
          <a:xfrm>
            <a:off x="7414698" y="4818678"/>
            <a:ext cx="4876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Mtx</a:t>
            </a:r>
          </a:p>
        </p:txBody>
      </p:sp>
      <p:sp>
        <p:nvSpPr>
          <p:cNvPr id="23" name="图形 2">
            <a:extLst>
              <a:ext uri="{FF2B5EF4-FFF2-40B4-BE49-F238E27FC236}">
                <a16:creationId xmlns:a16="http://schemas.microsoft.com/office/drawing/2014/main" id="{D1878C64-8842-40CE-AB8E-F9B13C5A316F}"/>
              </a:ext>
            </a:extLst>
          </p:cNvPr>
          <p:cNvSpPr txBox="1"/>
          <p:nvPr/>
        </p:nvSpPr>
        <p:spPr>
          <a:xfrm>
            <a:off x="3057572" y="4818678"/>
            <a:ext cx="24955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24" name="图形 2">
            <a:extLst>
              <a:ext uri="{FF2B5EF4-FFF2-40B4-BE49-F238E27FC236}">
                <a16:creationId xmlns:a16="http://schemas.microsoft.com/office/drawing/2014/main" id="{BC72F71F-284B-419E-A72F-116C45469C42}"/>
              </a:ext>
            </a:extLst>
          </p:cNvPr>
          <p:cNvSpPr txBox="1"/>
          <p:nvPr/>
        </p:nvSpPr>
        <p:spPr>
          <a:xfrm>
            <a:off x="8229752" y="3985717"/>
            <a:ext cx="146875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pHBLV sestrin2</a:t>
            </a:r>
          </a:p>
        </p:txBody>
      </p:sp>
      <p:sp>
        <p:nvSpPr>
          <p:cNvPr id="25" name="图形 2">
            <a:extLst>
              <a:ext uri="{FF2B5EF4-FFF2-40B4-BE49-F238E27FC236}">
                <a16:creationId xmlns:a16="http://schemas.microsoft.com/office/drawing/2014/main" id="{E426BE14-CDAD-4A18-ABD7-7A5970E4A24C}"/>
              </a:ext>
            </a:extLst>
          </p:cNvPr>
          <p:cNvSpPr txBox="1"/>
          <p:nvPr/>
        </p:nvSpPr>
        <p:spPr>
          <a:xfrm>
            <a:off x="8258317" y="2499817"/>
            <a:ext cx="137350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pHBLV control</a:t>
            </a:r>
          </a:p>
        </p:txBody>
      </p:sp>
      <p:sp>
        <p:nvSpPr>
          <p:cNvPr id="26" name="图形 2">
            <a:extLst>
              <a:ext uri="{FF2B5EF4-FFF2-40B4-BE49-F238E27FC236}">
                <a16:creationId xmlns:a16="http://schemas.microsoft.com/office/drawing/2014/main" id="{B6F9CAAA-025A-4B30-ACEB-DCF7BED849A9}"/>
              </a:ext>
            </a:extLst>
          </p:cNvPr>
          <p:cNvSpPr txBox="1"/>
          <p:nvPr/>
        </p:nvSpPr>
        <p:spPr>
          <a:xfrm>
            <a:off x="5122430" y="1708433"/>
            <a:ext cx="5829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HOS</a:t>
            </a:r>
          </a:p>
        </p:txBody>
      </p:sp>
    </p:spTree>
    <p:extLst>
      <p:ext uri="{BB962C8B-B14F-4D97-AF65-F5344CB8AC3E}">
        <p14:creationId xmlns:p14="http://schemas.microsoft.com/office/powerpoint/2010/main" val="76270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</TotalTime>
  <Words>28</Words>
  <Application>Microsoft Office PowerPoint</Application>
  <PresentationFormat>宽屏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26</cp:revision>
  <dcterms:created xsi:type="dcterms:W3CDTF">2021-06-15T01:43:45Z</dcterms:created>
  <dcterms:modified xsi:type="dcterms:W3CDTF">2021-06-15T11:03:19Z</dcterms:modified>
</cp:coreProperties>
</file>